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9" r:id="rId2"/>
  </p:sldIdLst>
  <p:sldSz cx="9144000" cy="6858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591" autoAdjust="0"/>
    <p:restoredTop sz="94629" autoAdjust="0"/>
  </p:normalViewPr>
  <p:slideViewPr>
    <p:cSldViewPr>
      <p:cViewPr>
        <p:scale>
          <a:sx n="160" d="100"/>
          <a:sy n="160" d="100"/>
        </p:scale>
        <p:origin x="-252" y="20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protein%2014092012%20necr%201%20fpr%20paper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protein%2014092012%20necr%201%20fpr%20paper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ATP%2005092012%20necrosis%20for%20paper%20200-1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ATP%2005092012%20necrosis%20for%20paper%20200-1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LDh%20total%20for%20paper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steatosis%20biochemical\LDh%20total%20for%20pape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400" b="1"/>
            </a:pPr>
            <a:r>
              <a:rPr lang="en-US" sz="1800" b="0" dirty="0"/>
              <a:t>protein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protein paper'!$T$14:$T$17</c:f>
                <c:numCache>
                  <c:formatCode>General</c:formatCode>
                  <c:ptCount val="4"/>
                  <c:pt idx="0">
                    <c:v>204.38161919545391</c:v>
                  </c:pt>
                  <c:pt idx="1">
                    <c:v>214.92143489410452</c:v>
                  </c:pt>
                  <c:pt idx="2">
                    <c:v>114.5211522810323</c:v>
                  </c:pt>
                  <c:pt idx="3">
                    <c:v>169.32362553618478</c:v>
                  </c:pt>
                </c:numCache>
              </c:numRef>
            </c:plus>
            <c:minus>
              <c:numRef>
                <c:f>'protein paper'!$T$14:$T$17</c:f>
                <c:numCache>
                  <c:formatCode>General</c:formatCode>
                  <c:ptCount val="4"/>
                  <c:pt idx="0">
                    <c:v>204.38161919545391</c:v>
                  </c:pt>
                  <c:pt idx="1">
                    <c:v>214.92143489410452</c:v>
                  </c:pt>
                  <c:pt idx="2">
                    <c:v>114.5211522810323</c:v>
                  </c:pt>
                  <c:pt idx="3">
                    <c:v>169.32362553618478</c:v>
                  </c:pt>
                </c:numCache>
              </c:numRef>
            </c:minus>
          </c:errBars>
          <c:cat>
            <c:strRef>
              <c:f>'protein paper'!$R$14:$R$17</c:f>
              <c:strCache>
                <c:ptCount val="4"/>
                <c:pt idx="0">
                  <c:v>ctr ISND</c:v>
                </c:pt>
                <c:pt idx="1">
                  <c:v>ISND 0.1 mM</c:v>
                </c:pt>
                <c:pt idx="2">
                  <c:v>ISND 0.5 mM</c:v>
                </c:pt>
                <c:pt idx="3">
                  <c:v>ISND 1 mM</c:v>
                </c:pt>
              </c:strCache>
            </c:strRef>
          </c:cat>
          <c:val>
            <c:numRef>
              <c:f>'protein paper'!$S$14:$S$17</c:f>
              <c:numCache>
                <c:formatCode>General</c:formatCode>
                <c:ptCount val="4"/>
                <c:pt idx="0">
                  <c:v>460.93139200000007</c:v>
                </c:pt>
                <c:pt idx="1">
                  <c:v>505.1388</c:v>
                </c:pt>
                <c:pt idx="2">
                  <c:v>461.55153600000006</c:v>
                </c:pt>
                <c:pt idx="3">
                  <c:v>519.579296000000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85152"/>
        <c:axId val="143194880"/>
      </c:barChart>
      <c:catAx>
        <c:axId val="150385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194880"/>
        <c:crosses val="autoZero"/>
        <c:auto val="1"/>
        <c:lblAlgn val="ctr"/>
        <c:lblOffset val="100"/>
        <c:noMultiLvlLbl val="0"/>
      </c:catAx>
      <c:valAx>
        <c:axId val="14319488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protein µg/sli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3851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800" b="0" dirty="0"/>
              <a:t>protein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protein paper'!$T$25:$T$28</c:f>
                <c:numCache>
                  <c:formatCode>General</c:formatCode>
                  <c:ptCount val="4"/>
                  <c:pt idx="0">
                    <c:v>226.22999192207578</c:v>
                  </c:pt>
                  <c:pt idx="1">
                    <c:v>288.20827405865271</c:v>
                  </c:pt>
                  <c:pt idx="2">
                    <c:v>175.45700955933884</c:v>
                  </c:pt>
                  <c:pt idx="3">
                    <c:v>221.33563658306517</c:v>
                  </c:pt>
                </c:numCache>
              </c:numRef>
            </c:plus>
            <c:minus>
              <c:numRef>
                <c:f>'protein paper'!$T$25:$T$28</c:f>
                <c:numCache>
                  <c:formatCode>General</c:formatCode>
                  <c:ptCount val="4"/>
                  <c:pt idx="0">
                    <c:v>226.22999192207578</c:v>
                  </c:pt>
                  <c:pt idx="1">
                    <c:v>288.20827405865271</c:v>
                  </c:pt>
                  <c:pt idx="2">
                    <c:v>175.45700955933884</c:v>
                  </c:pt>
                  <c:pt idx="3">
                    <c:v>221.33563658306517</c:v>
                  </c:pt>
                </c:numCache>
              </c:numRef>
            </c:minus>
          </c:errBars>
          <c:cat>
            <c:strRef>
              <c:f>'protein paper'!$R$25:$R$28</c:f>
              <c:strCache>
                <c:ptCount val="4"/>
                <c:pt idx="0">
                  <c:v>ctr PQ</c:v>
                </c:pt>
                <c:pt idx="1">
                  <c:v>PQ 1 µM</c:v>
                </c:pt>
                <c:pt idx="2">
                  <c:v>PQ 5 µM</c:v>
                </c:pt>
                <c:pt idx="3">
                  <c:v>PQ 10 µM</c:v>
                </c:pt>
              </c:strCache>
            </c:strRef>
          </c:cat>
          <c:val>
            <c:numRef>
              <c:f>'protein paper'!$S$25:$S$28</c:f>
              <c:numCache>
                <c:formatCode>General</c:formatCode>
                <c:ptCount val="4"/>
                <c:pt idx="0">
                  <c:v>511.49000533333339</c:v>
                </c:pt>
                <c:pt idx="1">
                  <c:v>532.51372800000001</c:v>
                </c:pt>
                <c:pt idx="2">
                  <c:v>530.29892800000005</c:v>
                </c:pt>
                <c:pt idx="3">
                  <c:v>434.796752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86176"/>
        <c:axId val="170992192"/>
      </c:barChart>
      <c:catAx>
        <c:axId val="150386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0992192"/>
        <c:crosses val="autoZero"/>
        <c:auto val="1"/>
        <c:lblAlgn val="ctr"/>
        <c:lblOffset val="100"/>
        <c:noMultiLvlLbl val="0"/>
      </c:catAx>
      <c:valAx>
        <c:axId val="170992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protein µg/sli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386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ATP fpr paper'!$L$75:$L$78</c:f>
                <c:numCache>
                  <c:formatCode>General</c:formatCode>
                  <c:ptCount val="4"/>
                  <c:pt idx="0">
                    <c:v>0.53505308174049859</c:v>
                  </c:pt>
                  <c:pt idx="1">
                    <c:v>0.72731101801086406</c:v>
                  </c:pt>
                  <c:pt idx="2">
                    <c:v>0.38045794527122179</c:v>
                  </c:pt>
                  <c:pt idx="3">
                    <c:v>0.97326449656812064</c:v>
                  </c:pt>
                </c:numCache>
              </c:numRef>
            </c:plus>
            <c:minus>
              <c:numRef>
                <c:f>'ATP fpr paper'!$L$75:$L$78</c:f>
                <c:numCache>
                  <c:formatCode>General</c:formatCode>
                  <c:ptCount val="4"/>
                  <c:pt idx="0">
                    <c:v>0.53505308174049859</c:v>
                  </c:pt>
                  <c:pt idx="1">
                    <c:v>0.72731101801086406</c:v>
                  </c:pt>
                  <c:pt idx="2">
                    <c:v>0.38045794527122179</c:v>
                  </c:pt>
                  <c:pt idx="3">
                    <c:v>0.97326449656812064</c:v>
                  </c:pt>
                </c:numCache>
              </c:numRef>
            </c:minus>
          </c:errBars>
          <c:cat>
            <c:strRef>
              <c:f>'ATP fpr paper'!$J$75:$J$78</c:f>
              <c:strCache>
                <c:ptCount val="4"/>
                <c:pt idx="0">
                  <c:v>ctr ISND</c:v>
                </c:pt>
                <c:pt idx="1">
                  <c:v>ISND 0.1 mM</c:v>
                </c:pt>
                <c:pt idx="2">
                  <c:v>ISND 0.5 mM</c:v>
                </c:pt>
                <c:pt idx="3">
                  <c:v>ISND 1 mM</c:v>
                </c:pt>
              </c:strCache>
            </c:strRef>
          </c:cat>
          <c:val>
            <c:numRef>
              <c:f>'ATP fpr paper'!$K$75:$K$78</c:f>
              <c:numCache>
                <c:formatCode>General</c:formatCode>
                <c:ptCount val="4"/>
                <c:pt idx="0">
                  <c:v>3.9010159999999998</c:v>
                </c:pt>
                <c:pt idx="1">
                  <c:v>3.7807279999999999</c:v>
                </c:pt>
                <c:pt idx="2">
                  <c:v>4.0041679999999999</c:v>
                </c:pt>
                <c:pt idx="3">
                  <c:v>3.949063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86688"/>
        <c:axId val="170993920"/>
      </c:barChart>
      <c:catAx>
        <c:axId val="150386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0993920"/>
        <c:crosses val="autoZero"/>
        <c:auto val="1"/>
        <c:lblAlgn val="ctr"/>
        <c:lblOffset val="100"/>
        <c:noMultiLvlLbl val="0"/>
      </c:catAx>
      <c:valAx>
        <c:axId val="17099392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(nmol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3866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ATP fpr paper'!$L$81:$L$84</c:f>
                <c:numCache>
                  <c:formatCode>General</c:formatCode>
                  <c:ptCount val="4"/>
                  <c:pt idx="0">
                    <c:v>0.76540829269089827</c:v>
                  </c:pt>
                  <c:pt idx="1">
                    <c:v>1.1218477139968677</c:v>
                  </c:pt>
                  <c:pt idx="2">
                    <c:v>0.78406658092281933</c:v>
                  </c:pt>
                  <c:pt idx="3">
                    <c:v>0.92960264291792882</c:v>
                  </c:pt>
                </c:numCache>
              </c:numRef>
            </c:plus>
            <c:minus>
              <c:numRef>
                <c:f>'ATP fpr paper'!$L$81:$L$84</c:f>
                <c:numCache>
                  <c:formatCode>General</c:formatCode>
                  <c:ptCount val="4"/>
                  <c:pt idx="0">
                    <c:v>0.76540829269089827</c:v>
                  </c:pt>
                  <c:pt idx="1">
                    <c:v>1.1218477139968677</c:v>
                  </c:pt>
                  <c:pt idx="2">
                    <c:v>0.78406658092281933</c:v>
                  </c:pt>
                  <c:pt idx="3">
                    <c:v>0.92960264291792882</c:v>
                  </c:pt>
                </c:numCache>
              </c:numRef>
            </c:minus>
          </c:errBars>
          <c:cat>
            <c:strRef>
              <c:f>'ATP fpr paper'!$J$81:$J$84</c:f>
              <c:strCache>
                <c:ptCount val="4"/>
                <c:pt idx="0">
                  <c:v>ctr PQ</c:v>
                </c:pt>
                <c:pt idx="1">
                  <c:v>PQ 1 µM</c:v>
                </c:pt>
                <c:pt idx="2">
                  <c:v>PQ 5 µM</c:v>
                </c:pt>
                <c:pt idx="3">
                  <c:v>PQ 10 µM</c:v>
                </c:pt>
              </c:strCache>
            </c:strRef>
          </c:cat>
          <c:val>
            <c:numRef>
              <c:f>'ATP fpr paper'!$K$81:$K$84</c:f>
              <c:numCache>
                <c:formatCode>General</c:formatCode>
                <c:ptCount val="4"/>
                <c:pt idx="0">
                  <c:v>3.7316720000000005</c:v>
                </c:pt>
                <c:pt idx="1">
                  <c:v>4.4948750000000004</c:v>
                </c:pt>
                <c:pt idx="2">
                  <c:v>3.4511119999999997</c:v>
                </c:pt>
                <c:pt idx="3">
                  <c:v>3.466568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88224"/>
        <c:axId val="170995648"/>
      </c:barChart>
      <c:catAx>
        <c:axId val="150388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0995648"/>
        <c:crosses val="autoZero"/>
        <c:auto val="1"/>
        <c:lblAlgn val="ctr"/>
        <c:lblOffset val="100"/>
        <c:noMultiLvlLbl val="0"/>
      </c:catAx>
      <c:valAx>
        <c:axId val="1709956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(nmol/slic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3882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LDH leakage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necrosis!$AN$104:$AN$108</c:f>
                <c:numCache>
                  <c:formatCode>General</c:formatCode>
                  <c:ptCount val="5"/>
                  <c:pt idx="0">
                    <c:v>0.31332092173999432</c:v>
                  </c:pt>
                  <c:pt idx="1">
                    <c:v>9.076526501549638E-2</c:v>
                  </c:pt>
                  <c:pt idx="2">
                    <c:v>0.15632114380338982</c:v>
                  </c:pt>
                  <c:pt idx="3">
                    <c:v>0.15245106683056658</c:v>
                  </c:pt>
                  <c:pt idx="4">
                    <c:v>0.24110231230745161</c:v>
                  </c:pt>
                </c:numCache>
              </c:numRef>
            </c:plus>
            <c:minus>
              <c:numRef>
                <c:f>necrosis!$AN$104:$AN$108</c:f>
                <c:numCache>
                  <c:formatCode>General</c:formatCode>
                  <c:ptCount val="5"/>
                  <c:pt idx="0">
                    <c:v>0.31332092173999432</c:v>
                  </c:pt>
                  <c:pt idx="1">
                    <c:v>9.076526501549638E-2</c:v>
                  </c:pt>
                  <c:pt idx="2">
                    <c:v>0.15632114380338982</c:v>
                  </c:pt>
                  <c:pt idx="3">
                    <c:v>0.15245106683056658</c:v>
                  </c:pt>
                  <c:pt idx="4">
                    <c:v>0.24110231230745161</c:v>
                  </c:pt>
                </c:numCache>
              </c:numRef>
            </c:minus>
          </c:errBars>
          <c:cat>
            <c:strRef>
              <c:f>necrosis!$AG$104:$AG$108</c:f>
              <c:strCache>
                <c:ptCount val="5"/>
                <c:pt idx="0">
                  <c:v>total LDH</c:v>
                </c:pt>
                <c:pt idx="1">
                  <c:v>ctr ISND</c:v>
                </c:pt>
                <c:pt idx="2">
                  <c:v>ISND 0.1 mM</c:v>
                </c:pt>
                <c:pt idx="3">
                  <c:v>ISND 0.5 mM</c:v>
                </c:pt>
                <c:pt idx="4">
                  <c:v>ISND 1 mM</c:v>
                </c:pt>
              </c:strCache>
            </c:strRef>
          </c:cat>
          <c:val>
            <c:numRef>
              <c:f>necrosis!$AM$104:$AM$108</c:f>
              <c:numCache>
                <c:formatCode>General</c:formatCode>
                <c:ptCount val="5"/>
                <c:pt idx="0">
                  <c:v>2.7280000000000002</c:v>
                </c:pt>
                <c:pt idx="1">
                  <c:v>0.59499999999999997</c:v>
                </c:pt>
                <c:pt idx="2">
                  <c:v>0.61109999999999998</c:v>
                </c:pt>
                <c:pt idx="3">
                  <c:v>0.64910000000000001</c:v>
                </c:pt>
                <c:pt idx="4">
                  <c:v>0.631300000000000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108992"/>
        <c:axId val="170997376"/>
      </c:barChart>
      <c:catAx>
        <c:axId val="1611089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0997376"/>
        <c:crosses val="autoZero"/>
        <c:auto val="1"/>
        <c:lblAlgn val="ctr"/>
        <c:lblOffset val="100"/>
        <c:noMultiLvlLbl val="0"/>
      </c:catAx>
      <c:valAx>
        <c:axId val="1709973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1108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LDH leakage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necrosis!$AN$111:$AN$115</c:f>
                <c:numCache>
                  <c:formatCode>General</c:formatCode>
                  <c:ptCount val="5"/>
                  <c:pt idx="0">
                    <c:v>0.31332092173999432</c:v>
                  </c:pt>
                  <c:pt idx="1">
                    <c:v>0.16390790096880625</c:v>
                  </c:pt>
                  <c:pt idx="2">
                    <c:v>0.2192134804249046</c:v>
                  </c:pt>
                  <c:pt idx="3">
                    <c:v>0.31937122252604094</c:v>
                  </c:pt>
                  <c:pt idx="4">
                    <c:v>0.22221515474872572</c:v>
                  </c:pt>
                </c:numCache>
              </c:numRef>
            </c:plus>
            <c:minus>
              <c:numRef>
                <c:f>necrosis!$AN$111:$AN$115</c:f>
                <c:numCache>
                  <c:formatCode>General</c:formatCode>
                  <c:ptCount val="5"/>
                  <c:pt idx="0">
                    <c:v>0.31332092173999432</c:v>
                  </c:pt>
                  <c:pt idx="1">
                    <c:v>0.16390790096880625</c:v>
                  </c:pt>
                  <c:pt idx="2">
                    <c:v>0.2192134804249046</c:v>
                  </c:pt>
                  <c:pt idx="3">
                    <c:v>0.31937122252604094</c:v>
                  </c:pt>
                  <c:pt idx="4">
                    <c:v>0.22221515474872572</c:v>
                  </c:pt>
                </c:numCache>
              </c:numRef>
            </c:minus>
          </c:errBars>
          <c:cat>
            <c:strRef>
              <c:f>necrosis!$AG$111:$AG$115</c:f>
              <c:strCache>
                <c:ptCount val="5"/>
                <c:pt idx="0">
                  <c:v>total LDH</c:v>
                </c:pt>
                <c:pt idx="1">
                  <c:v>ctr PQ</c:v>
                </c:pt>
                <c:pt idx="2">
                  <c:v>PQ 1 µM</c:v>
                </c:pt>
                <c:pt idx="3">
                  <c:v>PQ 5 µM</c:v>
                </c:pt>
                <c:pt idx="4">
                  <c:v>PQ 10 µM</c:v>
                </c:pt>
              </c:strCache>
            </c:strRef>
          </c:cat>
          <c:val>
            <c:numRef>
              <c:f>necrosis!$AM$111:$AM$115</c:f>
              <c:numCache>
                <c:formatCode>General</c:formatCode>
                <c:ptCount val="5"/>
                <c:pt idx="0">
                  <c:v>2.7280000000000002</c:v>
                </c:pt>
                <c:pt idx="1">
                  <c:v>0.60576666666666668</c:v>
                </c:pt>
                <c:pt idx="2">
                  <c:v>0.64639999999999997</c:v>
                </c:pt>
                <c:pt idx="3">
                  <c:v>0.70613333333333328</c:v>
                </c:pt>
                <c:pt idx="4">
                  <c:v>0.703299999999999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109504"/>
        <c:axId val="170999104"/>
      </c:barChart>
      <c:catAx>
        <c:axId val="161109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0999104"/>
        <c:crosses val="autoZero"/>
        <c:auto val="1"/>
        <c:lblAlgn val="ctr"/>
        <c:lblOffset val="100"/>
        <c:noMultiLvlLbl val="0"/>
      </c:catAx>
      <c:valAx>
        <c:axId val="1709991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11095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DFC91-B126-4A3E-9368-C6709E67190E}" type="datetimeFigureOut">
              <a:rPr lang="en-GB" smtClean="0"/>
              <a:pPr/>
              <a:t>21/05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4400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81F276-B2E4-47CD-92F6-8F00017626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428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53F7F-49DD-4F66-9F20-F9E348023A27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892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16A20-350C-443A-A0FC-324D86E8863A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02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8C32-C9B7-4021-A4E4-27043C073977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6305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C1F21-FA1C-4F32-81CB-65195DAFAFD9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580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3DBA9-E21B-48D8-892F-9725647D107E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732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D2CED-ACBC-4F65-AFE0-4F29AEBC576D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8459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9BB02-4115-40B8-A053-01F2226628EA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174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AD5F7-6CE7-4EE2-8A35-5A0A440B2145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350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8078E-E874-427F-8F6A-B675BE7F38A2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33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DDE-6B83-4FE8-9C0F-A6BAD3A18422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812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825CD-8357-47B1-B469-5C9E971A72C0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45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9D0D4A-3801-47F0-820D-1E8900A26F11}" type="datetime1">
              <a:rPr lang="en-GB" smtClean="0"/>
              <a:pPr/>
              <a:t>21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8E6C2-79E1-463A-9A70-4A8DC475BD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875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E6C2-79E1-463A-9A70-4A8DC475BD93}" type="slidenum">
              <a:rPr lang="en-GB" smtClean="0"/>
              <a:pPr/>
              <a:t>1</a:t>
            </a:fld>
            <a:endParaRPr lang="en-GB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629539"/>
              </p:ext>
            </p:extLst>
          </p:nvPr>
        </p:nvGraphicFramePr>
        <p:xfrm>
          <a:off x="395536" y="548680"/>
          <a:ext cx="3461941" cy="20505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0724235"/>
              </p:ext>
            </p:extLst>
          </p:nvPr>
        </p:nvGraphicFramePr>
        <p:xfrm>
          <a:off x="4139952" y="548680"/>
          <a:ext cx="3461941" cy="20505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0065413"/>
              </p:ext>
            </p:extLst>
          </p:nvPr>
        </p:nvGraphicFramePr>
        <p:xfrm>
          <a:off x="611560" y="2636912"/>
          <a:ext cx="3256012" cy="1973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2391597"/>
              </p:ext>
            </p:extLst>
          </p:nvPr>
        </p:nvGraphicFramePr>
        <p:xfrm>
          <a:off x="4355976" y="2636912"/>
          <a:ext cx="3256012" cy="1973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846228"/>
              </p:ext>
            </p:extLst>
          </p:nvPr>
        </p:nvGraphicFramePr>
        <p:xfrm>
          <a:off x="683568" y="4725144"/>
          <a:ext cx="3528392" cy="16900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3486394"/>
              </p:ext>
            </p:extLst>
          </p:nvPr>
        </p:nvGraphicFramePr>
        <p:xfrm>
          <a:off x="4499992" y="4797152"/>
          <a:ext cx="3528392" cy="16900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0" y="6488668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66545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76</TotalTime>
  <Words>30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lowska, Ewa</dc:creator>
  <cp:lastModifiedBy>Ewa Szalowska</cp:lastModifiedBy>
  <cp:revision>271</cp:revision>
  <cp:lastPrinted>2012-12-19T13:50:48Z</cp:lastPrinted>
  <dcterms:created xsi:type="dcterms:W3CDTF">2012-10-29T11:33:36Z</dcterms:created>
  <dcterms:modified xsi:type="dcterms:W3CDTF">2013-05-21T11:22:46Z</dcterms:modified>
</cp:coreProperties>
</file>